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="" xmlns:a16="http://schemas.microsoft.com/office/drawing/2014/main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="" xmlns:a16="http://schemas.microsoft.com/office/drawing/2014/main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="" xmlns:a16="http://schemas.microsoft.com/office/drawing/2014/main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="" xmlns:a16="http://schemas.microsoft.com/office/drawing/2014/main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="" xmlns:a16="http://schemas.microsoft.com/office/drawing/2014/main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="" xmlns:a16="http://schemas.microsoft.com/office/drawing/2014/main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="" xmlns:a16="http://schemas.microsoft.com/office/drawing/2014/main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="" xmlns:a16="http://schemas.microsoft.com/office/drawing/2014/main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="" xmlns:a16="http://schemas.microsoft.com/office/drawing/2014/main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="" xmlns:a16="http://schemas.microsoft.com/office/drawing/2014/main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="" xmlns:a16="http://schemas.microsoft.com/office/drawing/2014/main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="" xmlns:a16="http://schemas.microsoft.com/office/drawing/2014/main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="" xmlns:a16="http://schemas.microsoft.com/office/drawing/2014/main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="" xmlns:a16="http://schemas.microsoft.com/office/drawing/2014/main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="" xmlns:a16="http://schemas.microsoft.com/office/drawing/2014/main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="" xmlns:a16="http://schemas.microsoft.com/office/drawing/2014/main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="" xmlns:a16="http://schemas.microsoft.com/office/drawing/2014/main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="" xmlns:a16="http://schemas.microsoft.com/office/drawing/2014/main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="" xmlns:a16="http://schemas.microsoft.com/office/drawing/2014/main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="" xmlns:a16="http://schemas.microsoft.com/office/drawing/2014/main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="" xmlns:a16="http://schemas.microsoft.com/office/drawing/2014/main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="" xmlns:a16="http://schemas.microsoft.com/office/drawing/2014/main" id="{2BA7A764-5A8D-C441-B334-6BBFF9B6F7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0000311"/>
              </p:ext>
            </p:extLst>
          </p:nvPr>
        </p:nvGraphicFramePr>
        <p:xfrm>
          <a:off x="2041682" y="855022"/>
          <a:ext cx="8510418" cy="4695346"/>
        </p:xfrm>
        <a:graphic>
          <a:graphicData uri="http://schemas.openxmlformats.org/drawingml/2006/table">
            <a:tbl>
              <a:tblPr firstRow="1" firstCol="1">
                <a:tableStyleId>{5C22544A-7EE6-4342-B048-85BDC9FD1C3A}</a:tableStyleId>
              </a:tblPr>
              <a:tblGrid>
                <a:gridCol w="3110951">
                  <a:extLst>
                    <a:ext uri="{9D8B030D-6E8A-4147-A177-3AD203B41FA5}">
                      <a16:colId xmlns="" xmlns:a16="http://schemas.microsoft.com/office/drawing/2014/main" val="1667335219"/>
                    </a:ext>
                  </a:extLst>
                </a:gridCol>
                <a:gridCol w="1496963">
                  <a:extLst>
                    <a:ext uri="{9D8B030D-6E8A-4147-A177-3AD203B41FA5}">
                      <a16:colId xmlns="" xmlns:a16="http://schemas.microsoft.com/office/drawing/2014/main" val="2583089098"/>
                    </a:ext>
                  </a:extLst>
                </a:gridCol>
                <a:gridCol w="1152384">
                  <a:extLst>
                    <a:ext uri="{9D8B030D-6E8A-4147-A177-3AD203B41FA5}">
                      <a16:colId xmlns="" xmlns:a16="http://schemas.microsoft.com/office/drawing/2014/main" val="2334405132"/>
                    </a:ext>
                  </a:extLst>
                </a:gridCol>
                <a:gridCol w="1266973">
                  <a:extLst>
                    <a:ext uri="{9D8B030D-6E8A-4147-A177-3AD203B41FA5}">
                      <a16:colId xmlns="" xmlns:a16="http://schemas.microsoft.com/office/drawing/2014/main" val="2264681688"/>
                    </a:ext>
                  </a:extLst>
                </a:gridCol>
                <a:gridCol w="1483147">
                  <a:extLst>
                    <a:ext uri="{9D8B030D-6E8A-4147-A177-3AD203B41FA5}">
                      <a16:colId xmlns="" xmlns:a16="http://schemas.microsoft.com/office/drawing/2014/main" val="790193163"/>
                    </a:ext>
                  </a:extLst>
                </a:gridCol>
              </a:tblGrid>
              <a:tr h="41429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Parameters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All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N=10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Survivors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N=82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Non-survivors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N=19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P value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84765530"/>
                  </a:ext>
                </a:extLst>
              </a:tr>
              <a:tr h="3279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Haemoglobin (g/dL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0.8 ± 2.0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0.8 ± 1.9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0.4 ± 2.3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0.47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52831383"/>
                  </a:ext>
                </a:extLst>
              </a:tr>
              <a:tr h="3279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Platelets (.10</a:t>
                      </a:r>
                      <a:r>
                        <a:rPr lang="en-GB" sz="1200" baseline="30000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/L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310 ± 148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307 ± 153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315 ± 13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0.46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816579389"/>
                  </a:ext>
                </a:extLst>
              </a:tr>
              <a:tr h="3279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Creatinine (µ</a:t>
                      </a:r>
                      <a:r>
                        <a:rPr lang="en-GB" sz="1200" dirty="0" err="1">
                          <a:solidFill>
                            <a:schemeClr val="tx1"/>
                          </a:solidFill>
                          <a:effectLst/>
                        </a:rPr>
                        <a:t>mol</a:t>
                      </a: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/L) 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47 ± 17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46 ± 17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57 ± 177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0.9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4772852"/>
                  </a:ext>
                </a:extLst>
              </a:tr>
              <a:tr h="12428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KDIGO AKI (N, %)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Stage 0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Stage 1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Stage 2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Stage 3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62 (61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9 (9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8 (8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22 (22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52 (63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6 (7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6 (7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8 (23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0 (52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3 (16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2 (10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4 (22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0.6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70563438"/>
                  </a:ext>
                </a:extLst>
              </a:tr>
              <a:tr h="3279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Aspartate aminotransferase (IU/mL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70 ± 69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72 ± 75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59 ± 24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0.98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225978588"/>
                  </a:ext>
                </a:extLst>
              </a:tr>
              <a:tr h="3279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Alanine aminotransferase (IU/mL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61 ± 50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63 ± 53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50 ± 37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0.25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480154563"/>
                  </a:ext>
                </a:extLst>
              </a:tr>
              <a:tr h="41429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Total Bilirubin (µmol/L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2 ± 9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2 ± 8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4 ± 1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0.37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24007969"/>
                  </a:ext>
                </a:extLst>
              </a:tr>
              <a:tr h="3279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Prothrombin time (%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84 ± 1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85 ± 11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84 ± 10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0.20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806840927"/>
                  </a:ext>
                </a:extLst>
              </a:tr>
              <a:tr h="3279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PaO2/FiO2 (mmHg)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55 [111-251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63 [116-270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21 [82-143]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0.004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428477945"/>
                  </a:ext>
                </a:extLst>
              </a:tr>
              <a:tr h="32798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Arterial lactate (mmol/L)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.7 ± 0.6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1.7 ± 0.5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chemeClr val="tx1"/>
                          </a:solidFill>
                          <a:effectLst/>
                        </a:rPr>
                        <a:t>1.7 ± 0.6</a:t>
                      </a:r>
                      <a:endParaRPr lang="fr-FR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chemeClr val="tx1"/>
                          </a:solidFill>
                          <a:effectLst/>
                        </a:rPr>
                        <a:t>0.88</a:t>
                      </a: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67301382"/>
                  </a:ext>
                </a:extLst>
              </a:tr>
            </a:tbl>
          </a:graphicData>
        </a:graphic>
      </p:graphicFrame>
      <p:sp>
        <p:nvSpPr>
          <p:cNvPr id="4" name="ZoneTexte 3">
            <a:extLst>
              <a:ext uri="{FF2B5EF4-FFF2-40B4-BE49-F238E27FC236}">
                <a16:creationId xmlns="" xmlns:a16="http://schemas.microsoft.com/office/drawing/2014/main" id="{5BD2E487-10FB-2741-AFFD-45D2EC6A4BD1}"/>
              </a:ext>
            </a:extLst>
          </p:cNvPr>
          <p:cNvSpPr txBox="1"/>
          <p:nvPr/>
        </p:nvSpPr>
        <p:spPr>
          <a:xfrm>
            <a:off x="554182" y="5818910"/>
            <a:ext cx="114854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dditional  file 2</a:t>
            </a:r>
            <a:r>
              <a:rPr lang="en-GB" dirty="0"/>
              <a:t>. Baseline biological parameters of included ICU patients with SARS-CoV-2 infection according to 60-day outcome. Data are expressed as N (%) or median (1</a:t>
            </a:r>
            <a:r>
              <a:rPr lang="en-GB" baseline="30000" dirty="0"/>
              <a:t>st</a:t>
            </a:r>
            <a:r>
              <a:rPr lang="en-GB" dirty="0"/>
              <a:t>IQR-3</a:t>
            </a:r>
            <a:r>
              <a:rPr lang="en-GB" baseline="30000" dirty="0"/>
              <a:t>rd</a:t>
            </a:r>
            <a:r>
              <a:rPr lang="en-GB" dirty="0"/>
              <a:t>IQR). NS for non-significant.</a:t>
            </a:r>
            <a:r>
              <a:rPr lang="fr-FR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4167124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189</Words>
  <Application>Microsoft Office PowerPoint</Application>
  <PresentationFormat>Widescreen</PresentationFormat>
  <Paragraphs>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06:50Z</dcterms:modified>
</cp:coreProperties>
</file>